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6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320" y="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A0B696-7859-4EC1-A519-8063250698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F52E3E1-97EB-4C2A-AD15-5624711904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2935FC-A24C-4EDD-AB4A-F9AF88ABE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CD66BE-3937-46FF-89AA-7CE372AB7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180D28-8969-488C-972D-C31850C6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814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E3E8A8-60E5-44C9-BE36-A03C43C4BA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5D55B1-B8A2-4CC9-944E-CFF13B873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DB70E0-6466-4A55-8711-E10356B34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B71BD-D02B-45A5-A35A-C3E50E7A1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40AF46-F040-48C6-8EDB-C005E798E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6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31B11E7-4DA6-4627-8A81-E0BC4BF155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A09EBD-5BF1-4D0E-BE48-010CB04E6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630981-EB96-45A6-AB5B-66EBBF13A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9B487E-FBCC-4CDE-BDAC-E817B5EC1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845273-99D5-4B5A-8B87-3D19D27EC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89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453144-1E3B-43B1-A37A-BE41415A8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429DCF-5CE9-4A07-A435-8D2DDC0655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E3CC04-FDE2-4840-BA96-35045539E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87D178-ED18-45F2-BE82-EBC945CCE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E5349C-BC34-4E19-A1D4-A72AB19F1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025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F5498F-B100-44DE-94C3-1F64A18B05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B9A6B2-3D0B-4B4B-889F-3849967B84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F4A69A-77E3-4E37-9125-E16B15D8C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659D7C-974D-4057-97CF-B803B3EBE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E76DC1-2147-41EC-BB0B-9D30A013D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97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C28B14-682B-4BD8-A235-9A4DB67F2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59AC6A-C340-4607-888E-A1ED2EB0E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3C803A5-C34C-4AD9-8494-B63AD20C43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67D9E2-5F58-48CB-BE61-3AEFFDE95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8B9864-D007-4DDC-84B3-1875E9052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C4A79E-15FD-43F4-BCCD-46E1BCD7C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862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0F9388-F099-451C-BBD2-A17756D1E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F91D23-32DB-4959-9756-91F4D21DF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0BFE4EA-D3DB-4320-8EE6-650E72614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7400F7-7CD3-4ECA-B93F-FD867F76EC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E976320-F088-42ED-8159-5BC6963A58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043590-C847-49F1-86C3-29FFE3883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623F5C9-C065-4283-9E8E-F73398B6E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5EED3C7-7671-4E43-89D3-45B3937A0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20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C43AAE-567F-4ACF-9836-B6D607748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75D5A4D-6BC6-4B8B-AB63-6F6DE361C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AE1715-99E4-4653-8F9D-67665CAAE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7AE3871-0FBF-4FE2-B627-5A7F84996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303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2B5A12-7338-4A00-9B4F-F2283270D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FBD5BF-0FB6-4866-AEAB-FC059824F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333DCE-C377-4C2E-98E9-771D25BAF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23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0A97CA-0D84-43B7-AC06-D9FE880AB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3B87E9-35AE-4C5C-B0AA-879F7E402D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B6C410-21CC-4129-BD99-A8037E99B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FA486B-7489-44D1-8B0F-6328042A5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5C0A17-7FF2-491F-B909-100098864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9EA884-031C-456F-9935-318BC7571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2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9565CC-A06C-40C7-8CD8-A4D02BFD4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CAAB81F-B69F-4FD0-A02A-57A2DE6A0A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228B3E-3447-4B4C-8517-C5B1BDEE4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48515-C854-4101-A9B1-884524F14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9602FD-FD49-41CE-9471-DDBC6A1D2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5CFE28-B0BE-4734-9C4E-9B85846C5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10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4C9201-D464-4D46-A7E4-860791FFD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704A8F-1525-4765-80FF-A1C4DB1F1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735455-BBF2-47D4-A8EE-1C50C0D578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727499-805B-49B1-B15A-196160561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72361D-412E-4B48-A7DC-47AE318FD4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34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2F95C75-D589-4F3C-AD1E-E395870F2C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82" t="23136" r="12346" b="9444"/>
          <a:stretch/>
        </p:blipFill>
        <p:spPr>
          <a:xfrm rot="16200000" flipH="1">
            <a:off x="-678814" y="1654916"/>
            <a:ext cx="4317926" cy="2814558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FBCC72D5-ECB5-439A-B98F-C57AAD028B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4978" y="888027"/>
            <a:ext cx="2784783" cy="431769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DBE46C6-E9B5-4221-853B-82651FF8DF8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2781" y="887790"/>
            <a:ext cx="2784783" cy="4317691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D1FE3457-C7EF-4982-AC41-90CBD849413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8880" y="887789"/>
            <a:ext cx="2784783" cy="431769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696D2B7-9C19-46D2-A05E-C457E7D44986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2774" y="894141"/>
            <a:ext cx="72000" cy="43380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496BB3-B347-4128-9F47-F774347C2F25}"/>
              </a:ext>
            </a:extLst>
          </p:cNvPr>
          <p:cNvSpPr txBox="1"/>
          <p:nvPr/>
        </p:nvSpPr>
        <p:spPr>
          <a:xfrm rot="16200000">
            <a:off x="10941026" y="2892865"/>
            <a:ext cx="1371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radioactivity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1C6B521-C50B-4A6C-BEA4-A5A4563B4231}"/>
              </a:ext>
            </a:extLst>
          </p:cNvPr>
          <p:cNvSpPr txBox="1"/>
          <p:nvPr/>
        </p:nvSpPr>
        <p:spPr>
          <a:xfrm>
            <a:off x="11508681" y="810064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197EA5F-DF22-4A9A-AAE2-A41AEE6CA465}"/>
              </a:ext>
            </a:extLst>
          </p:cNvPr>
          <p:cNvSpPr txBox="1"/>
          <p:nvPr/>
        </p:nvSpPr>
        <p:spPr>
          <a:xfrm>
            <a:off x="11526728" y="492436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6F5A420-1BB5-41D4-B51D-5EDD504E69D3}"/>
              </a:ext>
            </a:extLst>
          </p:cNvPr>
          <p:cNvSpPr txBox="1"/>
          <p:nvPr/>
        </p:nvSpPr>
        <p:spPr>
          <a:xfrm>
            <a:off x="3749727" y="547598"/>
            <a:ext cx="11464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 h lighting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EC7D151-0A4D-46B1-8845-927DF2D9ECB9}"/>
              </a:ext>
            </a:extLst>
          </p:cNvPr>
          <p:cNvSpPr txBox="1"/>
          <p:nvPr/>
        </p:nvSpPr>
        <p:spPr>
          <a:xfrm>
            <a:off x="6620795" y="547598"/>
            <a:ext cx="11464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5 h lighting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222549-A119-4CCA-84DE-A89978104C00}"/>
              </a:ext>
            </a:extLst>
          </p:cNvPr>
          <p:cNvSpPr txBox="1"/>
          <p:nvPr/>
        </p:nvSpPr>
        <p:spPr>
          <a:xfrm>
            <a:off x="9559190" y="547598"/>
            <a:ext cx="1011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h lighting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C5DED32-FBEE-43D2-BBF9-45635E545CC0}"/>
              </a:ext>
            </a:extLst>
          </p:cNvPr>
          <p:cNvSpPr txBox="1"/>
          <p:nvPr/>
        </p:nvSpPr>
        <p:spPr>
          <a:xfrm>
            <a:off x="404791" y="547598"/>
            <a:ext cx="21210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eld of view of the PETI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D7B39A0-0524-4856-8A55-4D101E3E7349}"/>
              </a:ext>
            </a:extLst>
          </p:cNvPr>
          <p:cNvSpPr txBox="1"/>
          <p:nvPr/>
        </p:nvSpPr>
        <p:spPr>
          <a:xfrm>
            <a:off x="0" y="5770103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nimation of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photoynshtae translocation to strawberry fruits of Plant C in 0.5 h, 4.5 h and 9 h lighting treatments.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762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45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悠 悠</dc:creator>
  <cp:lastModifiedBy>Yuta Miyoshi</cp:lastModifiedBy>
  <cp:revision>11</cp:revision>
  <dcterms:created xsi:type="dcterms:W3CDTF">2021-03-28T23:34:59Z</dcterms:created>
  <dcterms:modified xsi:type="dcterms:W3CDTF">2021-03-31T10:11:54Z</dcterms:modified>
</cp:coreProperties>
</file>